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dhuravasal Krishnan, Janani (jananimk)" userId="6969b20d-d298-4095-ade9-5a3c5ff7904a" providerId="ADAL" clId="{5A8373DB-A693-4F0B-8961-15A89D720924}"/>
    <pc:docChg chg="undo redo modSld">
      <pc:chgData name="Madhuravasal Krishnan, Janani (jananimk)" userId="6969b20d-d298-4095-ade9-5a3c5ff7904a" providerId="ADAL" clId="{5A8373DB-A693-4F0B-8961-15A89D720924}" dt="2024-08-29T16:13:51.836" v="147" actId="164"/>
      <pc:docMkLst>
        <pc:docMk/>
      </pc:docMkLst>
      <pc:sldChg chg="addSp delSp modSp">
        <pc:chgData name="Madhuravasal Krishnan, Janani (jananimk)" userId="6969b20d-d298-4095-ade9-5a3c5ff7904a" providerId="ADAL" clId="{5A8373DB-A693-4F0B-8961-15A89D720924}" dt="2024-08-29T16:13:51.836" v="147" actId="164"/>
        <pc:sldMkLst>
          <pc:docMk/>
          <pc:sldMk cId="4137421979" sldId="257"/>
        </pc:sldMkLst>
        <pc:spChg chg="add del mod">
          <ac:chgData name="Madhuravasal Krishnan, Janani (jananimk)" userId="6969b20d-d298-4095-ade9-5a3c5ff7904a" providerId="ADAL" clId="{5A8373DB-A693-4F0B-8961-15A89D720924}" dt="2024-08-29T16:13:51.836" v="147" actId="164"/>
          <ac:spMkLst>
            <pc:docMk/>
            <pc:sldMk cId="4137421979" sldId="257"/>
            <ac:spMk id="4" creationId="{5CB7BA8C-EA45-43D2-BAD3-CB22E934E33B}"/>
          </ac:spMkLst>
        </pc:spChg>
        <pc:spChg chg="add del mod">
          <ac:chgData name="Madhuravasal Krishnan, Janani (jananimk)" userId="6969b20d-d298-4095-ade9-5a3c5ff7904a" providerId="ADAL" clId="{5A8373DB-A693-4F0B-8961-15A89D720924}" dt="2024-08-29T16:13:51.836" v="147" actId="164"/>
          <ac:spMkLst>
            <pc:docMk/>
            <pc:sldMk cId="4137421979" sldId="257"/>
            <ac:spMk id="5" creationId="{B4778D45-F687-4E02-BB52-BFADC467E174}"/>
          </ac:spMkLst>
        </pc:spChg>
        <pc:spChg chg="del">
          <ac:chgData name="Madhuravasal Krishnan, Janani (jananimk)" userId="6969b20d-d298-4095-ade9-5a3c5ff7904a" providerId="ADAL" clId="{5A8373DB-A693-4F0B-8961-15A89D720924}" dt="2024-08-28T15:39:44.478" v="0" actId="478"/>
          <ac:spMkLst>
            <pc:docMk/>
            <pc:sldMk cId="4137421979" sldId="257"/>
            <ac:spMk id="6" creationId="{65F75F82-6AE6-F11C-C851-E8B26C248892}"/>
          </ac:spMkLst>
        </pc:spChg>
        <pc:spChg chg="del">
          <ac:chgData name="Madhuravasal Krishnan, Janani (jananimk)" userId="6969b20d-d298-4095-ade9-5a3c5ff7904a" providerId="ADAL" clId="{5A8373DB-A693-4F0B-8961-15A89D720924}" dt="2024-08-28T15:39:44.478" v="0" actId="478"/>
          <ac:spMkLst>
            <pc:docMk/>
            <pc:sldMk cId="4137421979" sldId="257"/>
            <ac:spMk id="7" creationId="{601C5F72-899B-4310-82A4-3408758C4960}"/>
          </ac:spMkLst>
        </pc:spChg>
        <pc:spChg chg="add mod">
          <ac:chgData name="Madhuravasal Krishnan, Janani (jananimk)" userId="6969b20d-d298-4095-ade9-5a3c5ff7904a" providerId="ADAL" clId="{5A8373DB-A693-4F0B-8961-15A89D720924}" dt="2024-08-28T16:07:59.572" v="66" actId="947"/>
          <ac:spMkLst>
            <pc:docMk/>
            <pc:sldMk cId="4137421979" sldId="257"/>
            <ac:spMk id="8" creationId="{53449086-845F-45D1-B993-01C3A532FEF3}"/>
          </ac:spMkLst>
        </pc:spChg>
        <pc:grpChg chg="add mod">
          <ac:chgData name="Madhuravasal Krishnan, Janani (jananimk)" userId="6969b20d-d298-4095-ade9-5a3c5ff7904a" providerId="ADAL" clId="{5A8373DB-A693-4F0B-8961-15A89D720924}" dt="2024-08-29T16:13:51.836" v="147" actId="164"/>
          <ac:grpSpMkLst>
            <pc:docMk/>
            <pc:sldMk cId="4137421979" sldId="257"/>
            <ac:grpSpMk id="3" creationId="{67F643F8-4530-455C-9C96-2A55C313D67D}"/>
          </ac:grpSpMkLst>
        </pc:grpChg>
        <pc:graphicFrameChg chg="del">
          <ac:chgData name="Madhuravasal Krishnan, Janani (jananimk)" userId="6969b20d-d298-4095-ade9-5a3c5ff7904a" providerId="ADAL" clId="{5A8373DB-A693-4F0B-8961-15A89D720924}" dt="2024-08-28T15:39:44.478" v="0" actId="478"/>
          <ac:graphicFrameMkLst>
            <pc:docMk/>
            <pc:sldMk cId="4137421979" sldId="257"/>
            <ac:graphicFrameMk id="4" creationId="{67FA9AF8-BE23-491F-B821-B8BFBF32D5CB}"/>
          </ac:graphicFrameMkLst>
        </pc:graphicFrameChg>
        <pc:graphicFrameChg chg="del">
          <ac:chgData name="Madhuravasal Krishnan, Janani (jananimk)" userId="6969b20d-d298-4095-ade9-5a3c5ff7904a" providerId="ADAL" clId="{5A8373DB-A693-4F0B-8961-15A89D720924}" dt="2024-08-28T15:39:44.478" v="0" actId="478"/>
          <ac:graphicFrameMkLst>
            <pc:docMk/>
            <pc:sldMk cId="4137421979" sldId="257"/>
            <ac:graphicFrameMk id="5" creationId="{29EFD46D-4627-4134-BA9B-46E66F33A431}"/>
          </ac:graphicFrameMkLst>
        </pc:graphicFrameChg>
        <pc:picChg chg="add mod modCrop">
          <ac:chgData name="Madhuravasal Krishnan, Janani (jananimk)" userId="6969b20d-d298-4095-ade9-5a3c5ff7904a" providerId="ADAL" clId="{5A8373DB-A693-4F0B-8961-15A89D720924}" dt="2024-08-29T16:13:51.836" v="147" actId="164"/>
          <ac:picMkLst>
            <pc:docMk/>
            <pc:sldMk cId="4137421979" sldId="257"/>
            <ac:picMk id="2" creationId="{76E4E998-63AC-4EBA-9A5B-CDD929001B98}"/>
          </ac:picMkLst>
        </pc:picChg>
      </pc:sldChg>
    </pc:docChg>
  </pc:docChgLst>
  <pc:docChgLst>
    <pc:chgData name="Madhuravasal Krishnan, Janani (jananimk)" userId="6969b20d-d298-4095-ade9-5a3c5ff7904a" providerId="ADAL" clId="{CEE075D2-A41C-4527-AD3A-56B4E6ADFBB1}"/>
    <pc:docChg chg="modSld">
      <pc:chgData name="Madhuravasal Krishnan, Janani (jananimk)" userId="6969b20d-d298-4095-ade9-5a3c5ff7904a" providerId="ADAL" clId="{CEE075D2-A41C-4527-AD3A-56B4E6ADFBB1}" dt="2024-07-11T18:38:08.579" v="36" actId="123"/>
      <pc:docMkLst>
        <pc:docMk/>
      </pc:docMkLst>
      <pc:sldChg chg="modSp">
        <pc:chgData name="Madhuravasal Krishnan, Janani (jananimk)" userId="6969b20d-d298-4095-ade9-5a3c5ff7904a" providerId="ADAL" clId="{CEE075D2-A41C-4527-AD3A-56B4E6ADFBB1}" dt="2024-07-11T18:38:08.579" v="36" actId="123"/>
        <pc:sldMkLst>
          <pc:docMk/>
          <pc:sldMk cId="4137421979" sldId="257"/>
        </pc:sldMkLst>
        <pc:spChg chg="mod">
          <ac:chgData name="Madhuravasal Krishnan, Janani (jananimk)" userId="6969b20d-d298-4095-ade9-5a3c5ff7904a" providerId="ADAL" clId="{CEE075D2-A41C-4527-AD3A-56B4E6ADFBB1}" dt="2024-07-11T18:38:08.579" v="36" actId="123"/>
          <ac:spMkLst>
            <pc:docMk/>
            <pc:sldMk cId="4137421979" sldId="257"/>
            <ac:spMk id="7" creationId="{601C5F72-899B-4310-82A4-3408758C4960}"/>
          </ac:spMkLst>
        </pc:spChg>
        <pc:graphicFrameChg chg="mod">
          <ac:chgData name="Madhuravasal Krishnan, Janani (jananimk)" userId="6969b20d-d298-4095-ade9-5a3c5ff7904a" providerId="ADAL" clId="{CEE075D2-A41C-4527-AD3A-56B4E6ADFBB1}" dt="2024-07-11T18:35:43.403" v="32" actId="1036"/>
          <ac:graphicFrameMkLst>
            <pc:docMk/>
            <pc:sldMk cId="4137421979" sldId="257"/>
            <ac:graphicFrameMk id="4" creationId="{67FA9AF8-BE23-491F-B821-B8BFBF32D5CB}"/>
          </ac:graphicFrameMkLst>
        </pc:graphicFrameChg>
        <pc:graphicFrameChg chg="mod">
          <ac:chgData name="Madhuravasal Krishnan, Janani (jananimk)" userId="6969b20d-d298-4095-ade9-5a3c5ff7904a" providerId="ADAL" clId="{CEE075D2-A41C-4527-AD3A-56B4E6ADFBB1}" dt="2024-07-11T18:35:49.688" v="33" actId="1036"/>
          <ac:graphicFrameMkLst>
            <pc:docMk/>
            <pc:sldMk cId="4137421979" sldId="257"/>
            <ac:graphicFrameMk id="5" creationId="{29EFD46D-4627-4134-BA9B-46E66F33A431}"/>
          </ac:graphicFrameMkLst>
        </pc:graphicFrameChg>
      </pc:sldChg>
    </pc:docChg>
  </pc:docChgLst>
  <pc:docChgLst>
    <pc:chgData name="Madhuravasal Krishnan, Janani (jananimk)" userId="6969b20d-d298-4095-ade9-5a3c5ff7904a" providerId="ADAL" clId="{3C5943E4-ACC2-4CBC-AF09-09682438EFA9}"/>
    <pc:docChg chg="addSld delSld modSld">
      <pc:chgData name="Madhuravasal Krishnan, Janani (jananimk)" userId="6969b20d-d298-4095-ade9-5a3c5ff7904a" providerId="ADAL" clId="{3C5943E4-ACC2-4CBC-AF09-09682438EFA9}" dt="2024-06-12T20:11:05.635" v="22" actId="20577"/>
      <pc:docMkLst>
        <pc:docMk/>
      </pc:docMkLst>
      <pc:sldChg chg="modSp add">
        <pc:chgData name="Madhuravasal Krishnan, Janani (jananimk)" userId="6969b20d-d298-4095-ade9-5a3c5ff7904a" providerId="ADAL" clId="{3C5943E4-ACC2-4CBC-AF09-09682438EFA9}" dt="2024-06-12T20:11:05.635" v="22" actId="20577"/>
        <pc:sldMkLst>
          <pc:docMk/>
          <pc:sldMk cId="4137421979" sldId="257"/>
        </pc:sldMkLst>
        <pc:spChg chg="mod">
          <ac:chgData name="Madhuravasal Krishnan, Janani (jananimk)" userId="6969b20d-d298-4095-ade9-5a3c5ff7904a" providerId="ADAL" clId="{3C5943E4-ACC2-4CBC-AF09-09682438EFA9}" dt="2024-06-12T20:11:05.635" v="22" actId="20577"/>
          <ac:spMkLst>
            <pc:docMk/>
            <pc:sldMk cId="4137421979" sldId="257"/>
            <ac:spMk id="7" creationId="{601C5F72-899B-4310-82A4-3408758C496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3CBECE-6982-4E39-B418-8EA95CC8C630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C5E4E8-57CC-48DB-8DEA-31CB8317A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191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C5E4E8-57CC-48DB-8DEA-31CB8317A31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4953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F6F3FF-1634-46FB-8558-737B898BC6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D825C01-A93B-4CD1-AE70-82C42D00D3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70AA8-A85A-437D-8188-E48AC2ACD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B6C247-B2D2-4A71-BB34-98EF8233E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6F0C05-0436-4714-9618-25DBC69F9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86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42C39B-88E5-44F9-9A05-AC8FBFCCBF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7F1026-FA44-4CCE-8A75-F10261EE9B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8CED01-D738-480C-AAEA-B2ED483D3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9977B5-D753-4EBC-9B25-D7F40DFB1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7D8CB3-98D3-4FD3-A63A-8D3054825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957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65F8BEB-9B20-4045-B34F-95D47E0301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90A32D-5C8D-4DC0-B16B-4004DF98A6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CE0659-E408-435E-B14A-2F6F77214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1179E1-3023-4434-A924-4D0EB5114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C0238F-E676-406A-A3E6-1C0228C38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756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7601E3-BC5E-4752-BFFD-B5C158A271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2D9ED6-901D-465F-AF59-7E44D605FC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35D457-BE82-4080-9BCD-7B363FB83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9A7A79-EE5D-42F5-BE9C-B32CF15A0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299EB8-954C-40FE-AC10-3838CDAFE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606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3D5D4-E889-4071-A5C7-EBC5240694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AB7E13-F656-40E0-ADAC-ADFA4600B4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20CE46-9E74-4040-B53B-B02C55754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0FD2C1-128A-4177-AF5D-C389AD283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720634-7D4B-410B-AB13-3E6554745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321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FB5FBD-6845-4995-B1D7-F52C6A8A7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5B1102-8386-4594-8657-90F33FFB56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819FBF-7A28-4083-9DC7-620CDC89A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E45F86-73FA-4027-8235-5069418B1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6E3473-B44C-4D33-890C-D40122D1B8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619EB2-BA40-45B4-95F9-5B1DD220A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353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03AE75-36D8-4CD4-9212-5DCF26A843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D9669F-5026-4B6B-95E5-676A75819D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296D16-1C5E-46F5-A081-8EC9D9C6C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FF50208-01C0-499F-B10B-F9A00A74B5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EC26BA-9AC0-4037-9A4C-87A5FFD80D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ADDF87-4535-4362-91BC-7C98D5AD9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5000C3-1731-4FD0-B988-E64F64AC5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B8ADEFC-2B26-4B71-BF6D-1908484C3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046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570DC-DCC4-4F2D-B3B3-874CC70A01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25611C-CCDB-4CCF-B690-B5A5D88A3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A96AE4-D1D3-4C9A-A996-93774C71A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F5FF0A-119C-4274-9F2F-196BD2215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69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7352CA-F186-45D2-A2D7-8492E234D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589844-B7FB-4C6B-A3C2-47AA3CB90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AB2F01-F224-4D0B-982C-3FAAFF116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892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116FA-C32D-4FE1-9E00-B7D02F5AF8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81279C-A06F-4395-A1FB-33DC648704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80246E-B5CC-4B1F-8EC2-F0903F5279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F66587-B95F-4DBC-A7F8-71C18FA62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830BC7-D80B-4143-832A-5AC3FF272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CDB746-EDE8-42ED-B2C6-1752C43DA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861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4C7EB-0115-4042-8547-628FDA987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A2D116C-C3DD-4FB5-9780-97F79279D0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F07258-4668-4638-8918-2DEE600321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E650AD-A7F1-4E34-8525-62C5AE437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F51537-50AC-4DB9-9CD6-01749BFC2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48F35F-3970-4796-9F48-CE3178832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605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94A903-5624-45CF-83B6-D47E5D0BA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B021FA-9E01-41E2-90B0-FBEF5732D6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A989C0-60A4-46A7-99F8-E31CAEFF5E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3B7CC5-B96B-466D-AA3E-D687737FC8E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76B337-889F-4A8D-B21D-4FE8D35A6C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996F00-1FDD-458F-8191-EEC0872B8A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699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53449086-845F-45D1-B993-01C3A532FEF3}"/>
              </a:ext>
            </a:extLst>
          </p:cNvPr>
          <p:cNvSpPr txBox="1"/>
          <p:nvPr/>
        </p:nvSpPr>
        <p:spPr>
          <a:xfrm>
            <a:off x="0" y="6585103"/>
            <a:ext cx="121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</a:rPr>
              <a:t>Supplementary figure 7</a:t>
            </a:r>
            <a:r>
              <a:rPr lang="en-US" sz="1200" dirty="0">
                <a:latin typeface="Times New Roman" panose="02020603050405020304" pitchFamily="18" charset="0"/>
              </a:rPr>
              <a:t>: Dot plot of genes associated with HIV restriction factors in CD4</a:t>
            </a:r>
            <a:r>
              <a:rPr lang="en-US" sz="1200" baseline="30000" dirty="0">
                <a:latin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</a:rPr>
              <a:t> T lymphocytes infected with HIV </a:t>
            </a:r>
            <a:r>
              <a:rPr lang="en-US" sz="1200" baseline="-25000" dirty="0">
                <a:latin typeface="Times New Roman" panose="02020603050405020304" pitchFamily="18" charset="0"/>
              </a:rPr>
              <a:t>NL4-3</a:t>
            </a:r>
            <a:r>
              <a:rPr lang="en-US" sz="1200" dirty="0">
                <a:latin typeface="Times New Roman" panose="02020603050405020304" pitchFamily="18" charset="0"/>
              </a:rPr>
              <a:t> with and without fentanyl exposure.</a:t>
            </a:r>
            <a:endParaRPr lang="en-US" sz="1200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7F643F8-4530-455C-9C96-2A55C313D67D}"/>
              </a:ext>
            </a:extLst>
          </p:cNvPr>
          <p:cNvGrpSpPr/>
          <p:nvPr/>
        </p:nvGrpSpPr>
        <p:grpSpPr>
          <a:xfrm>
            <a:off x="1388799" y="609600"/>
            <a:ext cx="7544888" cy="5288280"/>
            <a:chOff x="1388799" y="609600"/>
            <a:chExt cx="7544888" cy="528828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6E4E998-63AC-4EBA-9A5B-CDD929001B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0858" t="12393" r="21324" b="6000"/>
            <a:stretch/>
          </p:blipFill>
          <p:spPr>
            <a:xfrm>
              <a:off x="3240504" y="609600"/>
              <a:ext cx="5693183" cy="528828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CB7BA8C-EA45-43D2-BAD3-CB22E934E33B}"/>
                </a:ext>
              </a:extLst>
            </p:cNvPr>
            <p:cNvSpPr txBox="1"/>
            <p:nvPr/>
          </p:nvSpPr>
          <p:spPr>
            <a:xfrm>
              <a:off x="1388799" y="3208698"/>
              <a:ext cx="18425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HIV / no fentanyl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4778D45-F687-4E02-BB52-BFADC467E174}"/>
                </a:ext>
              </a:extLst>
            </p:cNvPr>
            <p:cNvSpPr txBox="1"/>
            <p:nvPr/>
          </p:nvSpPr>
          <p:spPr>
            <a:xfrm>
              <a:off x="1715897" y="1516957"/>
              <a:ext cx="15119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HIV + fentany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37421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36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ravasal Krishnan, Janani (jananimk)</dc:creator>
  <cp:lastModifiedBy>Madhuravasal Krishnan, Janani (jananimk)</cp:lastModifiedBy>
  <cp:revision>2</cp:revision>
  <dcterms:created xsi:type="dcterms:W3CDTF">2024-06-12T20:05:21Z</dcterms:created>
  <dcterms:modified xsi:type="dcterms:W3CDTF">2024-08-29T16:13:58Z</dcterms:modified>
</cp:coreProperties>
</file>